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75" d="100"/>
          <a:sy n="75" d="100"/>
        </p:scale>
        <p:origin x="54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3934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0939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4572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490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5175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560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001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0924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8544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5025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698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7618F-6EB6-4854-8084-06426BEE87F0}" type="datetimeFigureOut">
              <a:rPr lang="en-GB" smtClean="0"/>
              <a:t>24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DA5BC-52FF-4DAD-B7B9-90A8814BF8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1057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803041" y="119619"/>
            <a:ext cx="3924000" cy="4824405"/>
            <a:chOff x="555141" y="678419"/>
            <a:chExt cx="3924000" cy="482440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2828" b="14923"/>
            <a:stretch/>
          </p:blipFill>
          <p:spPr>
            <a:xfrm>
              <a:off x="561975" y="2335767"/>
              <a:ext cx="3856668" cy="1531383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/>
            <a:srcRect l="3144" b="14815"/>
            <a:stretch/>
          </p:blipFill>
          <p:spPr>
            <a:xfrm>
              <a:off x="555141" y="3945491"/>
              <a:ext cx="3924000" cy="1557333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4"/>
            <a:srcRect l="2801" r="-1" b="12278"/>
            <a:stretch/>
          </p:blipFill>
          <p:spPr>
            <a:xfrm>
              <a:off x="561975" y="678419"/>
              <a:ext cx="3852000" cy="153042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5757609" y="1821677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CD28</a:t>
            </a:r>
            <a:endParaRPr lang="en-GB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5757609" y="3435278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CD86</a:t>
            </a:r>
            <a:endParaRPr lang="en-GB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5701504" y="208075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ABCG2</a:t>
            </a:r>
            <a:endParaRPr lang="en-GB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2638425" y="484187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0.1</a:t>
            </a:r>
            <a:endParaRPr lang="en-GB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3383264" y="4841875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1  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4116325" y="484187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10</a:t>
            </a:r>
            <a:endParaRPr lang="en-GB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4803456" y="484187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100</a:t>
            </a:r>
            <a:endParaRPr lang="en-GB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5493307" y="4841875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1000</a:t>
            </a:r>
            <a:endParaRPr lang="en-GB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6176353" y="4841875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10000</a:t>
            </a:r>
            <a:endParaRPr lang="en-GB" sz="12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232332" y="4026857"/>
            <a:ext cx="810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frequency</a:t>
            </a:r>
            <a:endParaRPr lang="en-GB" sz="12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2232333" y="724290"/>
            <a:ext cx="810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frequency</a:t>
            </a:r>
            <a:endParaRPr lang="en-GB" sz="12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2232332" y="2375574"/>
            <a:ext cx="810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frequency</a:t>
            </a:r>
            <a:endParaRPr lang="en-GB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2776327" y="5362685"/>
            <a:ext cx="38855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Supplementary Figure 1. </a:t>
            </a:r>
            <a:r>
              <a:rPr lang="en-GB" sz="1100" dirty="0" smtClean="0"/>
              <a:t>Samples of SMA solubilised membranes were analysed by dynamic light scattering. Typical DLS traces shown from three independent repeats with 10 replicate reads per experiment. </a:t>
            </a:r>
            <a:endParaRPr lang="en-GB" sz="1100" dirty="0"/>
          </a:p>
        </p:txBody>
      </p:sp>
      <p:sp>
        <p:nvSpPr>
          <p:cNvPr id="24" name="TextBox 23"/>
          <p:cNvSpPr txBox="1"/>
          <p:nvPr/>
        </p:nvSpPr>
        <p:spPr>
          <a:xfrm>
            <a:off x="4222713" y="5014855"/>
            <a:ext cx="10846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iameter (nm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428714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Kerr</dc:creator>
  <cp:lastModifiedBy>Ian Kerr</cp:lastModifiedBy>
  <cp:revision>5</cp:revision>
  <dcterms:created xsi:type="dcterms:W3CDTF">2020-01-24T09:05:58Z</dcterms:created>
  <dcterms:modified xsi:type="dcterms:W3CDTF">2020-01-24T09:33:36Z</dcterms:modified>
</cp:coreProperties>
</file>